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F4C2AE-1FCF-4CF4-A6D0-F25EF7AF41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46085-B590-4C65-B9FD-FCDE0B965B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772BB-3C3B-4AD7-830F-D4EB73D5DE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1962F-8BF4-49D9-AAFD-EEBA0B11F8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285DB6-8C5B-445A-B9ED-F90CD9A5D8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8E58B-7D05-4264-B207-4BBDBC887B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C78C7-8653-4BCA-BAB0-D2B7383EF9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4F5B7D-8FBB-4031-A03A-009E9DCB7C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733D3-ED14-4944-AA7B-0771D85E7C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A4E3F-761C-4F8D-9747-E2202B254D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05368-F3C1-4274-A8AA-A06BF1DF82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9E439F-C796-43A2-BBBE-8F0387C4BC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6DC397-A88D-4D4F-9160-2DE8C795D1A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28800" y="1144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25001" t="20825" r="25116" b="3687"/>
          <a:stretch/>
        </p:blipFill>
        <p:spPr>
          <a:xfrm>
            <a:off x="1981080" y="457200"/>
            <a:ext cx="5077080" cy="613404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3357720" y="320040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 flipH="1">
            <a:off x="6324480" y="762120"/>
            <a:ext cx="457200" cy="30456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6781680" y="762120"/>
            <a:ext cx="129564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664080" y="320040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 flipV="1">
            <a:off x="2057400" y="6529320"/>
            <a:ext cx="1523880" cy="10008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801960" y="320040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 flipV="1">
            <a:off x="2971800" y="5867280"/>
            <a:ext cx="30492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 flipV="1">
            <a:off x="4267080" y="5867280"/>
            <a:ext cx="68580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4048200" y="320040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 flipH="1" flipV="1">
            <a:off x="5409720" y="6038640"/>
            <a:ext cx="1143000" cy="43812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 flipH="1">
            <a:off x="762120" y="1066680"/>
            <a:ext cx="13716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917880" y="320040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 flipH="1" flipV="1">
            <a:off x="6019920" y="5657400"/>
            <a:ext cx="914400" cy="51444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959280" y="320040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 flipH="1" flipV="1">
            <a:off x="6324480" y="5562720"/>
            <a:ext cx="53352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133880" y="320040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 flipH="1" flipV="1">
            <a:off x="6238440" y="4933440"/>
            <a:ext cx="762120" cy="83844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048200" y="3200400"/>
            <a:ext cx="9144000" cy="360"/>
          </a:xfrm>
          <a:prstGeom prst="rect">
            <a:avLst/>
          </a:prstGeom>
          <a:solidFill>
            <a:srgbClr val="cce4f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7552800" y="5299200"/>
            <a:ext cx="1334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glutathione S transferase 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Yfyf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5867280" y="4495680"/>
            <a:ext cx="457200" cy="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7839000" y="609480"/>
            <a:ext cx="106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PTB-associated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splicing facto</a:t>
            </a: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157680" y="944640"/>
            <a:ext cx="575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transferr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160200" y="6486480"/>
            <a:ext cx="1206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fatty acid binding protein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150120" y="6307200"/>
            <a:ext cx="1207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eptidylprolyl isomerase A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8110440" y="6365880"/>
            <a:ext cx="781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peroxiredoxin 5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7911360" y="6056280"/>
            <a:ext cx="982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cofilin 1, non-muscl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7998120" y="5832360"/>
            <a:ext cx="91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yclophilin CyP-S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8082000" y="6203880"/>
            <a:ext cx="825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u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known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 flipH="1" flipV="1">
            <a:off x="6248520" y="5867280"/>
            <a:ext cx="45720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8271720" y="5651640"/>
            <a:ext cx="635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transgelin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8120160" y="5499000"/>
            <a:ext cx="781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eroxiredoxin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7401600" y="5075280"/>
            <a:ext cx="1499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lutathione S-transferase, alpha 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 flipH="1" flipV="1">
            <a:off x="6324120" y="4343400"/>
            <a:ext cx="68580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7497000" y="4813200"/>
            <a:ext cx="1406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glutathione S-transferase, mu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 flipH="1" flipV="1">
            <a:off x="5486400" y="4190760"/>
            <a:ext cx="990720" cy="15228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158760" y="4572000"/>
            <a:ext cx="1020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arbonic anhydrase 3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2209680" y="4038480"/>
            <a:ext cx="990720" cy="6098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163800" y="4789440"/>
            <a:ext cx="1308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triosephosphate isomer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2133720" y="4190760"/>
            <a:ext cx="1143000" cy="68580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152280" y="5391000"/>
            <a:ext cx="152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 Chain B, Glutathione S-Transferase Yfyf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2057400" y="4419360"/>
            <a:ext cx="1523880" cy="11430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 flipH="1">
            <a:off x="1294920" y="5562720"/>
            <a:ext cx="762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151920" y="5676840"/>
            <a:ext cx="678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Sod2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914400" y="5786280"/>
            <a:ext cx="121932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2133720" y="4571640"/>
            <a:ext cx="1371600" cy="121932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2133720" y="4610160"/>
            <a:ext cx="1981080" cy="13716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 flipH="1" flipV="1">
            <a:off x="6172200" y="4686480"/>
            <a:ext cx="838080" cy="9144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153360" y="5208480"/>
            <a:ext cx="1406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glutathione S-transferase, mu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2133720" y="4267080"/>
            <a:ext cx="1523880" cy="106704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159840" y="4984920"/>
            <a:ext cx="1406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lutathione S-transferase, mu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1981080" y="4191120"/>
            <a:ext cx="1524240" cy="914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159480" y="509760"/>
            <a:ext cx="1201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conitase 2, mitochondrial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1447920" y="609480"/>
            <a:ext cx="99036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2438280" y="609480"/>
            <a:ext cx="914400" cy="68580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154080" y="1174680"/>
            <a:ext cx="15537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S1-associated protein 1 isoform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2286000" y="1600200"/>
            <a:ext cx="685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1676520" y="1295280"/>
            <a:ext cx="304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 flipH="1" flipV="1">
            <a:off x="1980720" y="1294920"/>
            <a:ext cx="30492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156960" y="730080"/>
            <a:ext cx="703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ansketol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2286000" y="838080"/>
            <a:ext cx="1371600" cy="7621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159120" y="1417680"/>
            <a:ext cx="1303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fibrinogen, alpha polypeptid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2590920" y="1752480"/>
            <a:ext cx="761760" cy="4284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 flipH="1">
            <a:off x="2057400" y="1752480"/>
            <a:ext cx="53352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152280" y="1623960"/>
            <a:ext cx="804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dh4a1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2209680" y="1905120"/>
            <a:ext cx="10670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159480" y="2374920"/>
            <a:ext cx="96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cetyl-Coenzyme A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cyltransferase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1066680" y="2514600"/>
            <a:ext cx="106704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6172200" y="2209680"/>
            <a:ext cx="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 flipH="1">
            <a:off x="5638680" y="2209680"/>
            <a:ext cx="53352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6477120" y="2057400"/>
            <a:ext cx="1523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7941240" y="1828800"/>
            <a:ext cx="96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cetyl-Coenzyme A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cyltransferase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8376120" y="971640"/>
            <a:ext cx="5176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keratin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6629400" y="1066680"/>
            <a:ext cx="1752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 flipH="1">
            <a:off x="6324120" y="1066680"/>
            <a:ext cx="30492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8156880" y="1200240"/>
            <a:ext cx="729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TP synth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6553080" y="6477120"/>
            <a:ext cx="13716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6705720" y="6324480"/>
            <a:ext cx="1218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6934320" y="6172200"/>
            <a:ext cx="99036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 flipH="1">
            <a:off x="6857640" y="5943600"/>
            <a:ext cx="1143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7000920" y="5772240"/>
            <a:ext cx="121932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7010280" y="5610240"/>
            <a:ext cx="1143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6324480" y="4495680"/>
            <a:ext cx="685800" cy="91440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7010280" y="5410080"/>
            <a:ext cx="4572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 flipH="1">
            <a:off x="1219320" y="598176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156960" y="5880240"/>
            <a:ext cx="781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eroxiredoxin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1447920" y="6400800"/>
            <a:ext cx="2819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7010280" y="5181480"/>
            <a:ext cx="304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1600200" y="5334120"/>
            <a:ext cx="53352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1428840" y="4876920"/>
            <a:ext cx="6858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6477120" y="4343400"/>
            <a:ext cx="533160" cy="60948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7010280" y="4952880"/>
            <a:ext cx="30492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1600200" y="5095800"/>
            <a:ext cx="38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3505320" y="4114800"/>
            <a:ext cx="304560" cy="763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1200240" y="4657680"/>
            <a:ext cx="990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151200" y="4305240"/>
            <a:ext cx="1299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denylate kinase 2 isoform b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1504800" y="4429080"/>
            <a:ext cx="53352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 flipV="1">
            <a:off x="2057400" y="4066920"/>
            <a:ext cx="923760" cy="35244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7439400" y="4498920"/>
            <a:ext cx="1488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electron transferring flavoprotein,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beta polypeptide isoform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6934320" y="4648320"/>
            <a:ext cx="457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 flipH="1" flipV="1">
            <a:off x="6248160" y="4114800"/>
            <a:ext cx="685800" cy="533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 flipH="1" flipV="1">
            <a:off x="5866920" y="4038480"/>
            <a:ext cx="381240" cy="763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7723800" y="4299120"/>
            <a:ext cx="1155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unnamed protein product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 flipH="1" flipV="1">
            <a:off x="6095520" y="3809880"/>
            <a:ext cx="838440" cy="60984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6934320" y="4419720"/>
            <a:ext cx="6858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7723800" y="4098960"/>
            <a:ext cx="1155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unnamed protein product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 flipH="1">
            <a:off x="6934320" y="4191120"/>
            <a:ext cx="761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 flipH="1" flipV="1">
            <a:off x="6324480" y="3657600"/>
            <a:ext cx="60984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7912440" y="3622680"/>
            <a:ext cx="996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bonyl reduct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8126640" y="3402000"/>
            <a:ext cx="756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h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dhsc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7358760" y="3879720"/>
            <a:ext cx="1552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voltage-dependent anion channel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 flipH="1" flipV="1">
            <a:off x="5866920" y="3504960"/>
            <a:ext cx="685800" cy="15228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6553080" y="3657600"/>
            <a:ext cx="381240" cy="30492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 flipH="1">
            <a:off x="6950160" y="3975120"/>
            <a:ext cx="30456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 flipH="1">
            <a:off x="6019560" y="3429000"/>
            <a:ext cx="685800" cy="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 flipH="1" flipV="1">
            <a:off x="6171840" y="3504960"/>
            <a:ext cx="76212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6934320" y="3733920"/>
            <a:ext cx="914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6705720" y="3429000"/>
            <a:ext cx="228600" cy="7632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6934320" y="3505320"/>
            <a:ext cx="121896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8051400" y="3213000"/>
            <a:ext cx="8434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rpa2b1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 flipH="1">
            <a:off x="6324120" y="3352680"/>
            <a:ext cx="17528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 flipH="1">
            <a:off x="6324120" y="3124080"/>
            <a:ext cx="381240" cy="7632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6705720" y="3119400"/>
            <a:ext cx="99036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7743240" y="3008160"/>
            <a:ext cx="1146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malate dehydrogenase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7635240" y="2719440"/>
            <a:ext cx="125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similar to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lyceraldehyde-3-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hosphate dehydrogen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 flipH="1">
            <a:off x="5867280" y="2971800"/>
            <a:ext cx="91440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6781680" y="2971800"/>
            <a:ext cx="762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 flipH="1">
            <a:off x="4648320" y="2971800"/>
            <a:ext cx="213336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7883280" y="2556000"/>
            <a:ext cx="1002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ldolase 2, B isoform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 flipH="1">
            <a:off x="6324120" y="2895480"/>
            <a:ext cx="381240" cy="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 flipV="1">
            <a:off x="6705720" y="2666520"/>
            <a:ext cx="152280" cy="22860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6858000" y="2666880"/>
            <a:ext cx="9144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7789320" y="2260440"/>
            <a:ext cx="111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lutamate oxaloacetate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ransaminase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 flipV="1">
            <a:off x="6172200" y="2057040"/>
            <a:ext cx="30492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 flipH="1">
            <a:off x="6324120" y="2438280"/>
            <a:ext cx="30492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6629400" y="2438280"/>
            <a:ext cx="1066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8274600" y="2070000"/>
            <a:ext cx="592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ldolase A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 flipH="1">
            <a:off x="6019560" y="2209680"/>
            <a:ext cx="685800" cy="53352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6705720" y="2209680"/>
            <a:ext cx="152388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 flipH="1">
            <a:off x="5334120" y="1523880"/>
            <a:ext cx="838080" cy="9907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6181560" y="1523880"/>
            <a:ext cx="1590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7758360" y="1413000"/>
            <a:ext cx="1177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hosphoglycerate kinase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>
            <a:off x="5638680" y="2286000"/>
            <a:ext cx="0" cy="38088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 flipV="1">
            <a:off x="5638680" y="1752480"/>
            <a:ext cx="914400" cy="53352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6553080" y="1752480"/>
            <a:ext cx="13716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7941240" y="1600200"/>
            <a:ext cx="96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cetyl-Coenzyme A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c</a:t>
            </a: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et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yltransferase </a:t>
            </a: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4876920" y="1981080"/>
            <a:ext cx="685800" cy="228600"/>
          </a:xfrm>
          <a:prstGeom prst="ellipse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 flipV="1">
            <a:off x="5257800" y="1294920"/>
            <a:ext cx="914400" cy="68580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6172200" y="1295280"/>
            <a:ext cx="198108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2286000" y="3048120"/>
            <a:ext cx="990720" cy="7596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 flipH="1">
            <a:off x="1447920" y="3048120"/>
            <a:ext cx="83808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 flipV="1">
            <a:off x="3657600" y="5867280"/>
            <a:ext cx="38088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2146320" y="1295280"/>
            <a:ext cx="762120" cy="152640"/>
          </a:xfrm>
          <a:prstGeom prst="ellipse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 flipH="1" flipV="1">
            <a:off x="2133360" y="1066320"/>
            <a:ext cx="152280" cy="22860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2057400" y="1523880"/>
            <a:ext cx="0" cy="22860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1447920" y="1523880"/>
            <a:ext cx="60948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>
            <a:off x="914400" y="1752480"/>
            <a:ext cx="1066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1981080" y="1752480"/>
            <a:ext cx="228600" cy="152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 flipV="1">
            <a:off x="2438280" y="2590560"/>
            <a:ext cx="144792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 flipH="1">
            <a:off x="1447560" y="2743200"/>
            <a:ext cx="1066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>
            <a:off x="160560" y="2647800"/>
            <a:ext cx="1177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hosphoglycerate kinase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2133720" y="2514600"/>
            <a:ext cx="1904760" cy="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152280" y="1897200"/>
            <a:ext cx="1600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glutamate dehydrogenase 1 isoform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1371600" y="2057400"/>
            <a:ext cx="9144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2286000" y="1981080"/>
            <a:ext cx="762120" cy="228600"/>
          </a:xfrm>
          <a:prstGeom prst="ellipse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140400" y="2189160"/>
            <a:ext cx="1540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UDP-glucose pyrophosphorylase 2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1676520" y="2286000"/>
            <a:ext cx="12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 flipV="1">
            <a:off x="2971800" y="2133360"/>
            <a:ext cx="53352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>
            <a:off x="838080" y="838080"/>
            <a:ext cx="14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160560" y="3429000"/>
            <a:ext cx="98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electron transferring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flavoprotein, alpha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>
            <a:off x="1143000" y="3657600"/>
            <a:ext cx="106668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"/>
          <p:cNvSpPr/>
          <p:nvPr/>
        </p:nvSpPr>
        <p:spPr>
          <a:xfrm flipV="1">
            <a:off x="2209680" y="3504960"/>
            <a:ext cx="838440" cy="15228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"/>
          <p:cNvSpPr/>
          <p:nvPr/>
        </p:nvSpPr>
        <p:spPr>
          <a:xfrm>
            <a:off x="159480" y="2895480"/>
            <a:ext cx="125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ff"/>
                </a:solidFill>
                <a:latin typeface="Arial"/>
              </a:rPr>
              <a:t>similar to </a:t>
            </a: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glyceraldehyde-3-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phosphate dehydrogen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>
            <a:off x="3505320" y="4191120"/>
            <a:ext cx="6094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"/>
          <p:cNvSpPr/>
          <p:nvPr/>
        </p:nvSpPr>
        <p:spPr>
          <a:xfrm>
            <a:off x="159840" y="3213000"/>
            <a:ext cx="1142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lactate dehydrogen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"/>
          <p:cNvSpPr/>
          <p:nvPr/>
        </p:nvSpPr>
        <p:spPr>
          <a:xfrm flipV="1">
            <a:off x="2286000" y="3276360"/>
            <a:ext cx="1676520" cy="759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>
            <a:off x="1295280" y="335268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"/>
          <p:cNvSpPr/>
          <p:nvPr/>
        </p:nvSpPr>
        <p:spPr>
          <a:xfrm>
            <a:off x="159120" y="3746520"/>
            <a:ext cx="996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rbonyl reductase 1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"/>
          <p:cNvSpPr/>
          <p:nvPr/>
        </p:nvSpPr>
        <p:spPr>
          <a:xfrm>
            <a:off x="1143000" y="3886200"/>
            <a:ext cx="121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"/>
          <p:cNvSpPr/>
          <p:nvPr/>
        </p:nvSpPr>
        <p:spPr>
          <a:xfrm flipV="1">
            <a:off x="2362320" y="3352680"/>
            <a:ext cx="1752480" cy="5335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"/>
          <p:cNvSpPr/>
          <p:nvPr/>
        </p:nvSpPr>
        <p:spPr>
          <a:xfrm>
            <a:off x="158400" y="4022640"/>
            <a:ext cx="8434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nrpa2b1 protein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"/>
          <p:cNvSpPr/>
          <p:nvPr/>
        </p:nvSpPr>
        <p:spPr>
          <a:xfrm>
            <a:off x="1209600" y="412416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"/>
          <p:cNvSpPr/>
          <p:nvPr/>
        </p:nvSpPr>
        <p:spPr>
          <a:xfrm flipV="1">
            <a:off x="2209680" y="3276720"/>
            <a:ext cx="236232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"/>
          <p:cNvSpPr/>
          <p:nvPr/>
        </p:nvSpPr>
        <p:spPr>
          <a:xfrm>
            <a:off x="169920" y="6019920"/>
            <a:ext cx="860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enoyl Coenzyme 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ff"/>
                </a:solidFill>
                <a:latin typeface="Arial"/>
              </a:rPr>
              <a:t>A hydrat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"/>
          <p:cNvSpPr/>
          <p:nvPr/>
        </p:nvSpPr>
        <p:spPr>
          <a:xfrm flipV="1">
            <a:off x="2438280" y="4038120"/>
            <a:ext cx="2438640" cy="2133720"/>
          </a:xfrm>
          <a:prstGeom prst="line">
            <a:avLst/>
          </a:prstGeom>
          <a:ln w="9360">
            <a:solidFill>
              <a:srgbClr val="0000ff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"/>
          <p:cNvSpPr/>
          <p:nvPr/>
        </p:nvSpPr>
        <p:spPr>
          <a:xfrm>
            <a:off x="7750080" y="407880"/>
            <a:ext cx="1137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M2-type pyruvate kinase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"/>
          <p:cNvSpPr/>
          <p:nvPr/>
        </p:nvSpPr>
        <p:spPr>
          <a:xfrm flipH="1">
            <a:off x="4114800" y="533520"/>
            <a:ext cx="2362320" cy="1295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"/>
          <p:cNvSpPr/>
          <p:nvPr/>
        </p:nvSpPr>
        <p:spPr>
          <a:xfrm flipV="1">
            <a:off x="2971800" y="2133360"/>
            <a:ext cx="106668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"/>
          <p:cNvSpPr/>
          <p:nvPr/>
        </p:nvSpPr>
        <p:spPr>
          <a:xfrm>
            <a:off x="1447920" y="6629400"/>
            <a:ext cx="60948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"/>
          <p:cNvSpPr/>
          <p:nvPr/>
        </p:nvSpPr>
        <p:spPr>
          <a:xfrm>
            <a:off x="1066680" y="6172200"/>
            <a:ext cx="1371600" cy="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"/>
          <p:cNvSpPr/>
          <p:nvPr/>
        </p:nvSpPr>
        <p:spPr>
          <a:xfrm>
            <a:off x="6477120" y="533520"/>
            <a:ext cx="1295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06T09:17:38Z</dcterms:created>
  <dc:creator>msritort</dc:creator>
  <dc:description/>
  <dc:language>en-US</dc:language>
  <cp:lastModifiedBy>fschoppm</cp:lastModifiedBy>
  <dcterms:modified xsi:type="dcterms:W3CDTF">2009-09-02T18:01:18Z</dcterms:modified>
  <cp:revision>57</cp:revision>
  <dc:subject/>
  <dc:title>PowerPoint Presentation</dc:title>
</cp:coreProperties>
</file>